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C64B47-D240-DE04-62AA-5EE4D3012D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9E73208-4EC7-3D4F-8E67-69D068DC96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26A851-AF5B-0B04-A0D8-D4D2E23E8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444B7C-D4BC-654E-0EA7-D8ABB9E2C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C35568-82EF-C89B-C08C-DC77DDB25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384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AF37EA-B6D8-8B60-657C-DD8C1AAF0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CD3CEFC-DEFA-DE10-1D3D-4129060D91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B06CF8-4ECB-3E30-91BA-460E2BCF3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4599FF-E599-EE5A-9E11-06FE8E0B7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C314E1-B610-094C-AFA5-E1046DC70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35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E10F61-E765-0E06-6593-5F8FA1096B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EA85A48-220E-98F1-2016-EB48680ACE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D8F7FE-62BF-A2B8-392F-E5C4EAE3C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2EA11C-7ACD-D201-2C1C-A59DA7FA1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685050-05C8-5892-AE1A-85138E23C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8504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172984-BDAE-DB1B-FD7F-79EF007C5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2B6A10-3FC8-E671-A233-31BF53E76C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E21D12-153A-F663-7A52-8775F292F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C4D38E-B858-BD3A-595C-DCE45E44E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03EF0A-0378-D20F-9204-9A575890F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4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9C8DBB-CFAC-1650-DFEF-42CD5746F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F056AE-24E2-AD33-BF88-83546CD76C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CB95DE-9091-83C5-C1F4-E149A684D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62E5D7-96BC-2585-A57C-CD662E4691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0C369E-3221-3068-6AD5-5E3A113A6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3706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45F4BC-A2E8-69D3-5AD1-905810477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7A5D00E-F454-95CB-D453-D3C26C0084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66DCDC-57F9-C240-8B87-05E0A4B6E2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9BD015-C528-D10C-F884-33F740850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4B4651-40E3-A267-0CDC-5AE92FF55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8A17A1-7E30-0246-F4A5-C2E3E4B97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7123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A317F4-4A6F-373F-9506-FBD92B1B4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0349DA-4D0A-F7D8-F9D1-DC7F27FF04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ED809E-D5EB-74AF-DC6E-237ED771F8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E01EE7C-EDF1-9B09-AD2E-0804AC8898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DD3D636-3BFF-22DC-A417-7A369CB6EE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C3EF51F-AC02-76C3-D4BC-52BB076D1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2B7803F-87F2-560A-89D2-7E5FE0246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FBBF961-1689-30AB-EC47-726FBF10E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8345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2216C0-047C-96CB-48AF-E9EDB76FF3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C6B09C3-0675-E9A3-66BA-4D25A300C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755E0CC-3FE3-23B6-0FC9-E00D2D2E3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303C393-B5FB-5085-8DA4-43FA4BABC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899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BF98E2D-C1D1-575C-BF03-385F502FE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49DC141-2055-2469-BE96-05917E5CC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4745BEC-4591-6306-C44C-12762FBB6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963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297965-87B2-4FC7-0D8D-42A66D285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83692F6-931C-A90D-4F47-97C4143235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5C7FB1-BD81-9EF7-C122-9705F14DF2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2D6D96-4380-0480-649D-035E9D4D4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1CDFD1-FE52-7396-A3D0-BAED21704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AC750D2-F484-BE82-E8AD-37E055790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1381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37F857-C80E-BE51-81B2-76DD4097B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731C773-89CF-8A57-54F4-5B867B9AFB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EB35E8A-1D7A-4B75-C7E0-E8F8FAAE85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2614A9-82AE-7A5E-0615-D45F27272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CC638FC-1924-262E-4023-E52292681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465F84-279B-B0B4-3FD9-E6C9D434B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497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EF7F75-D3A5-FE41-4906-8C9D70A0E5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941365-FE2A-A404-FBF7-11A4004DCE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91C79A-203E-AA82-C459-2E3C9B324D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88604-9044-419A-8019-F72C9E7868C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C9B48A-096C-DB5B-8A29-F05D77A2C8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A3A91D-6F85-C4F3-3C5F-FFA40485BE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8F325-BE9D-4CAE-AFEE-E7C97B667C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7547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FC9A27A-4AD2-0330-9F0F-97B6B3AFEB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107" y="42861"/>
            <a:ext cx="3333750" cy="206922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B3A7076-A571-83B4-4941-81F3651ADF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8667" y="171067"/>
            <a:ext cx="3052238" cy="1936504"/>
          </a:xfrm>
          <a:prstGeom prst="rect">
            <a:avLst/>
          </a:prstGeom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B6062FE3-B2C9-259F-3F29-9FA0C55DA52B}"/>
              </a:ext>
            </a:extLst>
          </p:cNvPr>
          <p:cNvGrpSpPr/>
          <p:nvPr/>
        </p:nvGrpSpPr>
        <p:grpSpPr>
          <a:xfrm>
            <a:off x="637149" y="2239812"/>
            <a:ext cx="10384958" cy="1954467"/>
            <a:chOff x="551424" y="2265040"/>
            <a:chExt cx="10384958" cy="1954467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7BF5665A-9DFF-C866-ECCF-B4D30642E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1424" y="2265041"/>
              <a:ext cx="2996667" cy="1936505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AA11F6F2-56D5-52B3-0372-DD83C7E7FD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13440" y="2265041"/>
              <a:ext cx="3052239" cy="1954466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D4D293C4-7D06-4F70-B767-741EC5A50F1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31027" y="2265040"/>
              <a:ext cx="3005355" cy="1936505"/>
            </a:xfrm>
            <a:prstGeom prst="rect">
              <a:avLst/>
            </a:prstGeom>
          </p:spPr>
        </p:pic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05E697E4-07AD-246A-9B7B-48998C8A3E38}"/>
              </a:ext>
            </a:extLst>
          </p:cNvPr>
          <p:cNvGrpSpPr/>
          <p:nvPr/>
        </p:nvGrpSpPr>
        <p:grpSpPr>
          <a:xfrm>
            <a:off x="571723" y="4304045"/>
            <a:ext cx="10421809" cy="1954466"/>
            <a:chOff x="501750" y="4415142"/>
            <a:chExt cx="10421809" cy="1954466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7B8B045A-3450-FF04-7D16-9B2BB39F40A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1750" y="4415142"/>
              <a:ext cx="3048448" cy="1954466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77AA01E0-A6F9-0464-A156-4BD9E2C08FA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20904" y="4431805"/>
              <a:ext cx="3052238" cy="192114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8EFECA0-E795-C3FE-C14F-C737C571F2E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943848" y="4443124"/>
              <a:ext cx="2979711" cy="1898502"/>
            </a:xfrm>
            <a:prstGeom prst="rect">
              <a:avLst/>
            </a:prstGeom>
          </p:spPr>
        </p:pic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C1C65EFC-6C6D-E56D-1479-D98578B77649}"/>
              </a:ext>
            </a:extLst>
          </p:cNvPr>
          <p:cNvSpPr txBox="1"/>
          <p:nvPr/>
        </p:nvSpPr>
        <p:spPr>
          <a:xfrm>
            <a:off x="696545" y="6353474"/>
            <a:ext cx="1042424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ABA stress on gene expression levels of key enzymes in ginsenoside synthesis. X axis represents the duration of ABA treatment of ginseng hairy roots. The Y axis represents the relative expression level of genes in hairy roots of ginsen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9311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畅</dc:creator>
  <cp:lastModifiedBy>MDPI</cp:lastModifiedBy>
  <cp:revision>4</cp:revision>
  <dcterms:created xsi:type="dcterms:W3CDTF">2023-04-12T11:39:28Z</dcterms:created>
  <dcterms:modified xsi:type="dcterms:W3CDTF">2023-05-12T09:17:46Z</dcterms:modified>
</cp:coreProperties>
</file>